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99" d="100"/>
          <a:sy n="99" d="100"/>
        </p:scale>
        <p:origin x="912" y="9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FD932B-3322-4FB6-853A-4B620B476A0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CA4B3291-C95D-4C9A-B071-20E8E27974C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79FF15AC-4F2B-4AF0-A350-CE9718A2252E}"/>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5" name="Footer Placeholder 4">
            <a:extLst>
              <a:ext uri="{FF2B5EF4-FFF2-40B4-BE49-F238E27FC236}">
                <a16:creationId xmlns:a16="http://schemas.microsoft.com/office/drawing/2014/main" id="{34EF0811-0DCD-483E-B4AD-3C1E7289275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1FDDF5B-D478-447D-A206-2FF7A64E268E}"/>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29292944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635E46-C5B1-40F0-8517-82BD47437975}"/>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D9A5B59-D37F-4954-9F88-68A20B9A522A}"/>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B9D3929-CA8F-4D73-B08A-91EE8F0F9CC4}"/>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5" name="Footer Placeholder 4">
            <a:extLst>
              <a:ext uri="{FF2B5EF4-FFF2-40B4-BE49-F238E27FC236}">
                <a16:creationId xmlns:a16="http://schemas.microsoft.com/office/drawing/2014/main" id="{B1678D62-0465-4F7F-8F6D-2FDA25B5F62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4595003-7289-49C9-9190-948DC071E161}"/>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23705957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F264D30-7FD3-4251-8347-A1BB82AD055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03F19A3D-F1B7-4B1A-8265-DB1848BCF599}"/>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54694F0-33E8-4409-BD94-C784F92887FF}"/>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5" name="Footer Placeholder 4">
            <a:extLst>
              <a:ext uri="{FF2B5EF4-FFF2-40B4-BE49-F238E27FC236}">
                <a16:creationId xmlns:a16="http://schemas.microsoft.com/office/drawing/2014/main" id="{BBD2D3D9-0E72-4B6C-A52D-A20894530AB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B4EC15F-FFDC-4914-B611-B8B90301A1E5}"/>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21973665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0866D0-9DBB-4415-83F3-092692FE1BA0}"/>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D3B4BF7-F18F-4A6E-8CD7-3F570D51AA97}"/>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69422F5-F5F8-4B99-AF51-C88A626D33A6}"/>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5" name="Footer Placeholder 4">
            <a:extLst>
              <a:ext uri="{FF2B5EF4-FFF2-40B4-BE49-F238E27FC236}">
                <a16:creationId xmlns:a16="http://schemas.microsoft.com/office/drawing/2014/main" id="{B74CD3D0-8B6F-4018-B577-31442474839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DCD4B45-AE07-4043-B969-DA61B93D97F0}"/>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37660583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826306-4D33-4357-94D3-59FB75A63B5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62EEFF65-BE5C-456C-97F7-A443C7C8313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E9D84928-5240-4C6A-9E43-410F6D3B9EE8}"/>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5" name="Footer Placeholder 4">
            <a:extLst>
              <a:ext uri="{FF2B5EF4-FFF2-40B4-BE49-F238E27FC236}">
                <a16:creationId xmlns:a16="http://schemas.microsoft.com/office/drawing/2014/main" id="{B3F50BB2-F904-450E-B317-A5862133911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3F0EF61-BB5D-480D-B3F6-934630715626}"/>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33424326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F74480-0731-47F8-B41A-8B24493B6426}"/>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15BDE591-6E46-4DE2-9B88-C23638547AC3}"/>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20EFCAE5-69AF-4424-B231-E1E2FADB8F95}"/>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AAEB8226-9640-458C-8DB6-BCE3104B64B6}"/>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6" name="Footer Placeholder 5">
            <a:extLst>
              <a:ext uri="{FF2B5EF4-FFF2-40B4-BE49-F238E27FC236}">
                <a16:creationId xmlns:a16="http://schemas.microsoft.com/office/drawing/2014/main" id="{48EB26DD-4A66-4CD4-A86C-B43F41510BE2}"/>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9F4226B4-ACCF-4B88-B50A-AFBBFA935B05}"/>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39321799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5CD74A-6E0A-44FA-9D32-29FBB395AAB3}"/>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EAB6BC41-DAA0-4328-8784-638EB750D73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6FF2BA13-A1CB-4821-98CA-A18CC3FA867C}"/>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7B4E2FBC-ED29-49CD-A0D4-A5ADB7295EF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A5275B0C-0CEB-4B21-8193-2F2F811CE87F}"/>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E175571A-BB59-467F-87D2-238B8E2F1B18}"/>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8" name="Footer Placeholder 7">
            <a:extLst>
              <a:ext uri="{FF2B5EF4-FFF2-40B4-BE49-F238E27FC236}">
                <a16:creationId xmlns:a16="http://schemas.microsoft.com/office/drawing/2014/main" id="{885313B0-0B1E-4C03-8DB0-CCFCF939D877}"/>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FE7B5A54-EC14-41BB-B49F-406E9C06B08F}"/>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29265323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49DAF3-DDAA-439E-9AAE-F0C5F1DFAC45}"/>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E109C188-C76B-4206-8A4D-578FA776128C}"/>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4" name="Footer Placeholder 3">
            <a:extLst>
              <a:ext uri="{FF2B5EF4-FFF2-40B4-BE49-F238E27FC236}">
                <a16:creationId xmlns:a16="http://schemas.microsoft.com/office/drawing/2014/main" id="{C1D955E7-6CA6-48E5-AAE5-9B7824613C44}"/>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3D6DBBDB-9670-4A04-82CE-DCC8F09CE84A}"/>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20535156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9CDA7B0-83EC-452E-9E29-121C4E00EBEC}"/>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3" name="Footer Placeholder 2">
            <a:extLst>
              <a:ext uri="{FF2B5EF4-FFF2-40B4-BE49-F238E27FC236}">
                <a16:creationId xmlns:a16="http://schemas.microsoft.com/office/drawing/2014/main" id="{5DAB03F7-0FE4-4F97-9CDB-5EB98EC3FCA4}"/>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2714B769-76ED-40E6-B036-CFC9AEB17BBC}"/>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24458924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8AE79C-38CB-4C9B-9918-19D850224E8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E9EFF502-F7BE-46F6-82BB-F3FB3F95A9B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5FBA7EF7-1164-4341-B8A7-C26C4F50C61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A7BB5A7-5F89-47D9-BBDD-B92870C3E8E7}"/>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6" name="Footer Placeholder 5">
            <a:extLst>
              <a:ext uri="{FF2B5EF4-FFF2-40B4-BE49-F238E27FC236}">
                <a16:creationId xmlns:a16="http://schemas.microsoft.com/office/drawing/2014/main" id="{E0EA979E-B2F5-4E4B-91B3-8E18D0DB375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ACF9B0B-F605-4889-A62D-090341DB8CFA}"/>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34192773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E61B51-8330-4B67-BD82-90B2DE2348A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0BD41125-DF10-4CD6-B23F-E6D7D5F0CCA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224B1BAC-8B24-4409-8259-B8E17E28FCB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7AF8B55-C06B-4D70-963D-72593EDAF7A0}"/>
              </a:ext>
            </a:extLst>
          </p:cNvPr>
          <p:cNvSpPr>
            <a:spLocks noGrp="1"/>
          </p:cNvSpPr>
          <p:nvPr>
            <p:ph type="dt" sz="half" idx="10"/>
          </p:nvPr>
        </p:nvSpPr>
        <p:spPr/>
        <p:txBody>
          <a:bodyPr/>
          <a:lstStyle/>
          <a:p>
            <a:fld id="{ED286B94-7D8D-4D48-9C59-9C98E2632F49}" type="datetimeFigureOut">
              <a:rPr lang="en-GB" smtClean="0"/>
              <a:t>17/03/2018</a:t>
            </a:fld>
            <a:endParaRPr lang="en-GB"/>
          </a:p>
        </p:txBody>
      </p:sp>
      <p:sp>
        <p:nvSpPr>
          <p:cNvPr id="6" name="Footer Placeholder 5">
            <a:extLst>
              <a:ext uri="{FF2B5EF4-FFF2-40B4-BE49-F238E27FC236}">
                <a16:creationId xmlns:a16="http://schemas.microsoft.com/office/drawing/2014/main" id="{AF754E84-4459-44D9-96FA-F7175F73AA8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1BED740A-4E88-456C-8B1E-0C977F4C0F03}"/>
              </a:ext>
            </a:extLst>
          </p:cNvPr>
          <p:cNvSpPr>
            <a:spLocks noGrp="1"/>
          </p:cNvSpPr>
          <p:nvPr>
            <p:ph type="sldNum" sz="quarter" idx="12"/>
          </p:nvPr>
        </p:nvSpPr>
        <p:spPr/>
        <p:txBody>
          <a:bodyPr/>
          <a:lstStyle/>
          <a:p>
            <a:fld id="{E192779D-1548-4D72-85D4-C1424C3A6A62}" type="slidenum">
              <a:rPr lang="en-GB" smtClean="0"/>
              <a:t>‹#›</a:t>
            </a:fld>
            <a:endParaRPr lang="en-GB"/>
          </a:p>
        </p:txBody>
      </p:sp>
    </p:spTree>
    <p:extLst>
      <p:ext uri="{BB962C8B-B14F-4D97-AF65-F5344CB8AC3E}">
        <p14:creationId xmlns:p14="http://schemas.microsoft.com/office/powerpoint/2010/main" val="31626075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FA41DEE-BFA2-48C3-82A8-DAD95990E1F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B8217A63-83FB-48C7-B88C-FD798E1CC8F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E5D81E8-1397-44DB-BD4B-0BD4AB84A44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D286B94-7D8D-4D48-9C59-9C98E2632F49}" type="datetimeFigureOut">
              <a:rPr lang="en-GB" smtClean="0"/>
              <a:t>17/03/2018</a:t>
            </a:fld>
            <a:endParaRPr lang="en-GB"/>
          </a:p>
        </p:txBody>
      </p:sp>
      <p:sp>
        <p:nvSpPr>
          <p:cNvPr id="5" name="Footer Placeholder 4">
            <a:extLst>
              <a:ext uri="{FF2B5EF4-FFF2-40B4-BE49-F238E27FC236}">
                <a16:creationId xmlns:a16="http://schemas.microsoft.com/office/drawing/2014/main" id="{82D99102-A5AB-4131-B9AC-C29C113FE31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CC120D51-A2D9-4596-853F-55271E88710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192779D-1548-4D72-85D4-C1424C3A6A62}" type="slidenum">
              <a:rPr lang="en-GB" smtClean="0"/>
              <a:t>‹#›</a:t>
            </a:fld>
            <a:endParaRPr lang="en-GB"/>
          </a:p>
        </p:txBody>
      </p:sp>
    </p:spTree>
    <p:extLst>
      <p:ext uri="{BB962C8B-B14F-4D97-AF65-F5344CB8AC3E}">
        <p14:creationId xmlns:p14="http://schemas.microsoft.com/office/powerpoint/2010/main" val="2503515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7">
            <a:extLst>
              <a:ext uri="{FF2B5EF4-FFF2-40B4-BE49-F238E27FC236}">
                <a16:creationId xmlns:a16="http://schemas.microsoft.com/office/drawing/2014/main" id="{834D880B-2BA2-4AE6-BA26-AE991802637C}"/>
              </a:ext>
            </a:extLst>
          </p:cNvPr>
          <p:cNvGraphicFramePr>
            <a:graphicFrameLocks noGrp="1"/>
          </p:cNvGraphicFramePr>
          <p:nvPr>
            <p:extLst>
              <p:ext uri="{D42A27DB-BD31-4B8C-83A1-F6EECF244321}">
                <p14:modId xmlns:p14="http://schemas.microsoft.com/office/powerpoint/2010/main" val="3344196108"/>
              </p:ext>
            </p:extLst>
          </p:nvPr>
        </p:nvGraphicFramePr>
        <p:xfrm>
          <a:off x="907605" y="591298"/>
          <a:ext cx="10470573" cy="6029856"/>
        </p:xfrm>
        <a:graphic>
          <a:graphicData uri="http://schemas.openxmlformats.org/drawingml/2006/table">
            <a:tbl>
              <a:tblPr firstRow="1" firstCol="1" bandRow="1"/>
              <a:tblGrid>
                <a:gridCol w="1949621">
                  <a:extLst>
                    <a:ext uri="{9D8B030D-6E8A-4147-A177-3AD203B41FA5}">
                      <a16:colId xmlns:a16="http://schemas.microsoft.com/office/drawing/2014/main" val="1164762591"/>
                    </a:ext>
                  </a:extLst>
                </a:gridCol>
                <a:gridCol w="1844915">
                  <a:extLst>
                    <a:ext uri="{9D8B030D-6E8A-4147-A177-3AD203B41FA5}">
                      <a16:colId xmlns:a16="http://schemas.microsoft.com/office/drawing/2014/main" val="2893209489"/>
                    </a:ext>
                  </a:extLst>
                </a:gridCol>
                <a:gridCol w="1589432">
                  <a:extLst>
                    <a:ext uri="{9D8B030D-6E8A-4147-A177-3AD203B41FA5}">
                      <a16:colId xmlns:a16="http://schemas.microsoft.com/office/drawing/2014/main" val="1962600892"/>
                    </a:ext>
                  </a:extLst>
                </a:gridCol>
                <a:gridCol w="1493104">
                  <a:extLst>
                    <a:ext uri="{9D8B030D-6E8A-4147-A177-3AD203B41FA5}">
                      <a16:colId xmlns:a16="http://schemas.microsoft.com/office/drawing/2014/main" val="3362442132"/>
                    </a:ext>
                  </a:extLst>
                </a:gridCol>
                <a:gridCol w="1677386">
                  <a:extLst>
                    <a:ext uri="{9D8B030D-6E8A-4147-A177-3AD203B41FA5}">
                      <a16:colId xmlns:a16="http://schemas.microsoft.com/office/drawing/2014/main" val="1266316964"/>
                    </a:ext>
                  </a:extLst>
                </a:gridCol>
                <a:gridCol w="1916115">
                  <a:extLst>
                    <a:ext uri="{9D8B030D-6E8A-4147-A177-3AD203B41FA5}">
                      <a16:colId xmlns:a16="http://schemas.microsoft.com/office/drawing/2014/main" val="1079047609"/>
                    </a:ext>
                  </a:extLst>
                </a:gridCol>
              </a:tblGrid>
              <a:tr h="234299">
                <a:tc>
                  <a:txBody>
                    <a:bodyPr/>
                    <a:lstStyle/>
                    <a:p>
                      <a:pPr algn="l">
                        <a:spcAft>
                          <a:spcPts val="0"/>
                        </a:spcAft>
                      </a:pPr>
                      <a:r>
                        <a:rPr lang="en-GB" sz="1000" b="1" dirty="0">
                          <a:effectLst/>
                          <a:latin typeface="Times New Roman" panose="02020603050405020304" pitchFamily="18" charset="0"/>
                          <a:ea typeface="Cambria" panose="02040503050406030204" pitchFamily="18" charset="0"/>
                          <a:cs typeface="Times New Roman" panose="02020603050405020304" pitchFamily="18" charset="0"/>
                        </a:rPr>
                        <a:t>Author</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b="1"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kroyd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ekkers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yrne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hang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huo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947135888"/>
                  </a:ext>
                </a:extLst>
              </a:tr>
              <a:tr h="1305456">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itl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Interprofessional, simulation-base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echnology-enhanced learning to</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improve physical health care in</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psychiatry: The recognition an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assessment of medical problems in</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psychiatric settings course</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nhancing the quality of antibiotic prescribing in Primary Care: Qualitative evaluation of a blended learning interven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he use of technology in health research capacity development: lesson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from a cross country research partnership</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Developing an e-learning education programm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for staff nurses: Processes and outcom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ffectiveness of e-learning in hospit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093621355"/>
                  </a:ext>
                </a:extLst>
              </a:tr>
              <a:tr h="234299">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Study desig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udit of desig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Randomised control trai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se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967463687"/>
                  </a:ext>
                </a:extLst>
              </a:tr>
              <a:tr h="351448">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Participant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Registered Mental Health Nurse and Health-care Assistant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GP and Nurse Practitioner</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Health Researcher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urs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edical Practitioner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636046531"/>
                  </a:ext>
                </a:extLst>
              </a:tr>
              <a:tr h="117149">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Sample siz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o dat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31</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5</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42</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358</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336753103"/>
                  </a:ext>
                </a:extLst>
              </a:tr>
              <a:tr h="234299">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ype of TEL use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imulation technology enhanced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lended' approach (e-learning plus face-to-face) + video sim pat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lended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webpag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 learning</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544263449"/>
                  </a:ext>
                </a:extLst>
              </a:tr>
              <a:tr h="117149">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ype of TEL evalua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EL DoH Framework</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urvey + semi structured interview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urvey, interview, quantitativ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urvey+ knowledge scor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ostal Surve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324891750"/>
                  </a:ext>
                </a:extLst>
              </a:tr>
              <a:tr h="1536886">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Key study finding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e TEL framework was used to audit this programme and proved to be a useful set of standards for this purpose in auditing innovations in learning using technology. It both highlighted ways in which this course adhered to principles and improvements that can be made for future courses.</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articipants interviewed judged th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ontent of the programme, as well as the deliver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ethods as timely, necessary and feasible. The online aspect of the training was evaluate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ositively, with an emphasis on its promotion of</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independent learning and flexibility in accessing the program.</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Communication</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at is most suitable and convenient to all</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partners needs to be continuously updated and negotiate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as skills and infrastructure change. Mixed feelings from students towards</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eir online learning experience. Capacity can be adde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rough blended learning</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programmes.</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Knowledge scores were very high</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for both programmes. Also,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97.6% learners felt satisfied or very satisfied with ELP</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nd TICP, and would choose the same programm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for future in-service continuing education.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Results indicated that the learning climate demonstrated a considerable effect on e-learning satisfaction,</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and that environments with a favourable learning climate increased learners’ learning satisfaction. E-learning satisfaction exerted a significant influence on the effectiveness of e-learning.</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8575" marR="5857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168148930"/>
                  </a:ext>
                </a:extLst>
              </a:tr>
            </a:tbl>
          </a:graphicData>
        </a:graphic>
      </p:graphicFrame>
      <p:sp>
        <p:nvSpPr>
          <p:cNvPr id="9" name="TextBox 8">
            <a:extLst>
              <a:ext uri="{FF2B5EF4-FFF2-40B4-BE49-F238E27FC236}">
                <a16:creationId xmlns:a16="http://schemas.microsoft.com/office/drawing/2014/main" id="{2A1442D0-4A44-4832-A97B-FF541EC1C9D9}"/>
              </a:ext>
            </a:extLst>
          </p:cNvPr>
          <p:cNvSpPr txBox="1"/>
          <p:nvPr/>
        </p:nvSpPr>
        <p:spPr>
          <a:xfrm>
            <a:off x="907605" y="226646"/>
            <a:ext cx="6017846" cy="276999"/>
          </a:xfrm>
          <a:prstGeom prst="rect">
            <a:avLst/>
          </a:prstGeom>
          <a:noFill/>
        </p:spPr>
        <p:txBody>
          <a:bodyPr wrap="square" rtlCol="0">
            <a:spAutoFit/>
          </a:bodyPr>
          <a:lstStyle/>
          <a:p>
            <a:r>
              <a:rPr lang="en-GB" sz="1200" b="1" dirty="0">
                <a:latin typeface="+mj-lt"/>
              </a:rPr>
              <a:t>Summary of information from studies</a:t>
            </a:r>
            <a:endParaRPr lang="en-GB" sz="1200" dirty="0">
              <a:latin typeface="+mj-lt"/>
            </a:endParaRPr>
          </a:p>
        </p:txBody>
      </p:sp>
    </p:spTree>
    <p:extLst>
      <p:ext uri="{BB962C8B-B14F-4D97-AF65-F5344CB8AC3E}">
        <p14:creationId xmlns:p14="http://schemas.microsoft.com/office/powerpoint/2010/main" val="41085268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64E2FF9A-52F1-49EB-8101-8A56FF334E94}"/>
              </a:ext>
            </a:extLst>
          </p:cNvPr>
          <p:cNvGraphicFramePr>
            <a:graphicFrameLocks noGrp="1"/>
          </p:cNvGraphicFramePr>
          <p:nvPr>
            <p:extLst>
              <p:ext uri="{D42A27DB-BD31-4B8C-83A1-F6EECF244321}">
                <p14:modId xmlns:p14="http://schemas.microsoft.com/office/powerpoint/2010/main" val="1032774848"/>
              </p:ext>
            </p:extLst>
          </p:nvPr>
        </p:nvGraphicFramePr>
        <p:xfrm>
          <a:off x="765908" y="947042"/>
          <a:ext cx="10525369" cy="4876800"/>
        </p:xfrm>
        <a:graphic>
          <a:graphicData uri="http://schemas.openxmlformats.org/drawingml/2006/table">
            <a:tbl>
              <a:tblPr firstRow="1" firstCol="1" bandRow="1"/>
              <a:tblGrid>
                <a:gridCol w="1990908">
                  <a:extLst>
                    <a:ext uri="{9D8B030D-6E8A-4147-A177-3AD203B41FA5}">
                      <a16:colId xmlns:a16="http://schemas.microsoft.com/office/drawing/2014/main" val="2610786038"/>
                    </a:ext>
                  </a:extLst>
                </a:gridCol>
                <a:gridCol w="1854952">
                  <a:extLst>
                    <a:ext uri="{9D8B030D-6E8A-4147-A177-3AD203B41FA5}">
                      <a16:colId xmlns:a16="http://schemas.microsoft.com/office/drawing/2014/main" val="928916233"/>
                    </a:ext>
                  </a:extLst>
                </a:gridCol>
                <a:gridCol w="1402781">
                  <a:extLst>
                    <a:ext uri="{9D8B030D-6E8A-4147-A177-3AD203B41FA5}">
                      <a16:colId xmlns:a16="http://schemas.microsoft.com/office/drawing/2014/main" val="1784275320"/>
                    </a:ext>
                  </a:extLst>
                </a:gridCol>
                <a:gridCol w="1503731">
                  <a:extLst>
                    <a:ext uri="{9D8B030D-6E8A-4147-A177-3AD203B41FA5}">
                      <a16:colId xmlns:a16="http://schemas.microsoft.com/office/drawing/2014/main" val="3805076613"/>
                    </a:ext>
                  </a:extLst>
                </a:gridCol>
                <a:gridCol w="1579443">
                  <a:extLst>
                    <a:ext uri="{9D8B030D-6E8A-4147-A177-3AD203B41FA5}">
                      <a16:colId xmlns:a16="http://schemas.microsoft.com/office/drawing/2014/main" val="1271279123"/>
                    </a:ext>
                  </a:extLst>
                </a:gridCol>
                <a:gridCol w="2193554">
                  <a:extLst>
                    <a:ext uri="{9D8B030D-6E8A-4147-A177-3AD203B41FA5}">
                      <a16:colId xmlns:a16="http://schemas.microsoft.com/office/drawing/2014/main" val="1073473639"/>
                    </a:ext>
                  </a:extLst>
                </a:gridCol>
              </a:tblGrid>
              <a:tr h="238581">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Author</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ortese-Peske. M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Fontaine.G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Gill.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Goldberg Goetz.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eartfield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487896025"/>
                  </a:ext>
                </a:extLst>
              </a:tr>
              <a:tr h="596451">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itl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Improving Cultural Competency and Disease Awareness Among Oncology Nurs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ring for Adult T-Cell Leukaemia and Lymphoma Patient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valuation of a Web-Based E-Learning Platform for Brief</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otivational Interviewing by Nurses in Cardiovascular Car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 learning and Professional Development-never too old to lear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Development and Alumni Assessment of a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Interdisciplinary PhD Program Offered through a Blended Learning Environmen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e-Learning competency for practice nurses: An Evaluation report</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933177164"/>
                  </a:ext>
                </a:extLst>
              </a:tr>
              <a:tr h="119290">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Study desig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on-equivalent control group desig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ilot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se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se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923023098"/>
                  </a:ext>
                </a:extLst>
              </a:tr>
              <a:tr h="119290">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Participant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cology Nurs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urs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ealthcare Profession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HP</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ractice Nurs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599776971"/>
                  </a:ext>
                </a:extLst>
              </a:tr>
              <a:tr h="119290">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Sample siz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30</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28</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o dat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26</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500</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059941115"/>
                  </a:ext>
                </a:extLst>
              </a:tr>
              <a:tr h="119290">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ype of TEL use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 Learn onlin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Web based e learning platform</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CD ROM</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lended, multi medi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LM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877634371"/>
                  </a:ext>
                </a:extLst>
              </a:tr>
              <a:tr h="357871">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ype of TEL evalua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he Health Prof Exp online learning Framework +survey + knowledge scor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heng + Vander Heijdens framework</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cores + surve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urvey -postal, online and Telephone interview</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Questionnair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elephone survey/ open tex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381450321"/>
                  </a:ext>
                </a:extLst>
              </a:tr>
              <a:tr h="1431483">
                <a:tc>
                  <a:txBody>
                    <a:bodyPr/>
                    <a:lstStyle/>
                    <a:p>
                      <a:pPr algn="l">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Key study finding</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Demonstrated an e-learning intervention focusing</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 a rare disease found in a culturally distinct population is an effective strategy for educating nursing staff.</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TimesNewRomanPSMT"/>
                          <a:cs typeface="Times New Roman" panose="02020603050405020304" pitchFamily="18" charset="0"/>
                        </a:rPr>
                        <a:t>The e-learning platform for brief MI was feasible an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TimesNewRomanPSMT"/>
                          <a:cs typeface="Times New Roman" panose="02020603050405020304" pitchFamily="18" charset="0"/>
                        </a:rPr>
                        <a:t>acceptable to nurses in cardiovascular care. Preliminary post training results regarding perceived skil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TimesNewRomanPSMT"/>
                          <a:cs typeface="Times New Roman" panose="02020603050405020304" pitchFamily="18" charset="0"/>
                        </a:rPr>
                        <a:t>+clinical use of brief MI were all more favourable than those observed in the pretraining assessmen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valuation of the cours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as demonstrated that it is possible to cover both CPD an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PD in a positive and enjoyable way, and to promote positiv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learning with a view to improving patient car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Blended learning programs are well suited for allie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health professionals because they offer face-to-face interaction,</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mentoring relationships, as well as</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positive traits inherent in distance-based education.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Blended learning programmes, can help meet the growing demand for doctorate trained allied health professionals</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Decisions about e-learning design options, strategies to engage and support learners with significant variation in individual online learning skills need to be balanced with workplace realities.</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lgn="l">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Issues associated with e-learning competency   greatly influence progress in e health generally.</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59645" marR="596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160151513"/>
                  </a:ext>
                </a:extLst>
              </a:tr>
            </a:tbl>
          </a:graphicData>
        </a:graphic>
      </p:graphicFrame>
    </p:spTree>
    <p:extLst>
      <p:ext uri="{BB962C8B-B14F-4D97-AF65-F5344CB8AC3E}">
        <p14:creationId xmlns:p14="http://schemas.microsoft.com/office/powerpoint/2010/main" val="39337979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A1B48CF-6F59-4DC4-9706-525D8123E766}"/>
              </a:ext>
            </a:extLst>
          </p:cNvPr>
          <p:cNvGraphicFramePr>
            <a:graphicFrameLocks noGrp="1"/>
          </p:cNvGraphicFramePr>
          <p:nvPr>
            <p:extLst>
              <p:ext uri="{D42A27DB-BD31-4B8C-83A1-F6EECF244321}">
                <p14:modId xmlns:p14="http://schemas.microsoft.com/office/powerpoint/2010/main" val="2815916503"/>
              </p:ext>
            </p:extLst>
          </p:nvPr>
        </p:nvGraphicFramePr>
        <p:xfrm>
          <a:off x="1888826" y="375140"/>
          <a:ext cx="8461239" cy="6072386"/>
        </p:xfrm>
        <a:graphic>
          <a:graphicData uri="http://schemas.openxmlformats.org/drawingml/2006/table">
            <a:tbl>
              <a:tblPr firstRow="1" firstCol="1" bandRow="1"/>
              <a:tblGrid>
                <a:gridCol w="1328414">
                  <a:extLst>
                    <a:ext uri="{9D8B030D-6E8A-4147-A177-3AD203B41FA5}">
                      <a16:colId xmlns:a16="http://schemas.microsoft.com/office/drawing/2014/main" val="4227570910"/>
                    </a:ext>
                  </a:extLst>
                </a:gridCol>
                <a:gridCol w="1451949">
                  <a:extLst>
                    <a:ext uri="{9D8B030D-6E8A-4147-A177-3AD203B41FA5}">
                      <a16:colId xmlns:a16="http://schemas.microsoft.com/office/drawing/2014/main" val="3970450213"/>
                    </a:ext>
                  </a:extLst>
                </a:gridCol>
                <a:gridCol w="1450256">
                  <a:extLst>
                    <a:ext uri="{9D8B030D-6E8A-4147-A177-3AD203B41FA5}">
                      <a16:colId xmlns:a16="http://schemas.microsoft.com/office/drawing/2014/main" val="2868124113"/>
                    </a:ext>
                  </a:extLst>
                </a:gridCol>
                <a:gridCol w="1441796">
                  <a:extLst>
                    <a:ext uri="{9D8B030D-6E8A-4147-A177-3AD203B41FA5}">
                      <a16:colId xmlns:a16="http://schemas.microsoft.com/office/drawing/2014/main" val="3402128619"/>
                    </a:ext>
                  </a:extLst>
                </a:gridCol>
                <a:gridCol w="1121960">
                  <a:extLst>
                    <a:ext uri="{9D8B030D-6E8A-4147-A177-3AD203B41FA5}">
                      <a16:colId xmlns:a16="http://schemas.microsoft.com/office/drawing/2014/main" val="1300948008"/>
                    </a:ext>
                  </a:extLst>
                </a:gridCol>
                <a:gridCol w="1666864">
                  <a:extLst>
                    <a:ext uri="{9D8B030D-6E8A-4147-A177-3AD203B41FA5}">
                      <a16:colId xmlns:a16="http://schemas.microsoft.com/office/drawing/2014/main" val="1328172817"/>
                    </a:ext>
                  </a:extLst>
                </a:gridCol>
              </a:tblGrid>
              <a:tr h="151618">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Author</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Inglebeen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Konstantinidis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Bef>
                          <a:spcPts val="200"/>
                        </a:spcBef>
                        <a:spcAft>
                          <a:spcPts val="0"/>
                        </a:spcAft>
                        <a:tabLst>
                          <a:tab pos="2139315" algn="r"/>
                        </a:tabLs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Lotrecchiano G.R.</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b="1"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Moreira.I.C et al</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dirty="0">
                          <a:solidFill>
                            <a:schemeClr val="tx1"/>
                          </a:solidFill>
                          <a:effectLst/>
                          <a:latin typeface="Cambria" panose="02040503050406030204" pitchFamily="18" charset="0"/>
                          <a:ea typeface="Times New Roman" panose="02020603050405020304" pitchFamily="18" charset="0"/>
                          <a:cs typeface="Times New Roman" panose="02020603050405020304" pitchFamily="18" charset="0"/>
                        </a:rPr>
                        <a:t>Popescu et al</a:t>
                      </a: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5563111"/>
                  </a:ext>
                </a:extLst>
              </a:tr>
              <a:tr h="767883">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itl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xploring three approaches to offer distance learning courses through a social network of health researchers in three African countri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 SCORM compliant e-learning Platform for Cervical Cancer Preven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lended Learning: Strengths, Challenges, and Lessons Learned in an Interprofession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raining Program</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Development and Assessment of an E-Learning Course on Breas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Imaging for Radiographers: A Stratified Randomized Controlle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ri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 Web-based E-training Platform for biomedical engineering educa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913226764"/>
                  </a:ext>
                </a:extLst>
              </a:tr>
              <a:tr h="191971">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Study desig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se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RC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s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181562489"/>
                  </a:ext>
                </a:extLst>
              </a:tr>
              <a:tr h="95985">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Participant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edical and public Health Profession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General Practitioner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ealthcare Profession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Radiographer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edical and biomedical profession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4223634644"/>
                  </a:ext>
                </a:extLst>
              </a:tr>
              <a:tr h="95985">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Sample siz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38</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30</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Unclear from dat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120</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205</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317856919"/>
                  </a:ext>
                </a:extLst>
              </a:tr>
              <a:tr h="95985">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ype of TEL use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LMS/ webcast/ blended/ video</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LMS onlin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lended, multi medi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asynchronou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 training platform</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236165792"/>
                  </a:ext>
                </a:extLst>
              </a:tr>
              <a:tr h="191971">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Type of TEL evalua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ctivity analysis + focus group self-evalua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CORM scores + surve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Questionnair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User satisfaction surve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ctivity analysis + self-evalua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509431467"/>
                  </a:ext>
                </a:extLst>
              </a:tr>
              <a:tr h="2719586">
                <a:tc>
                  <a:txBody>
                    <a:bodyPr/>
                    <a:lstStyle/>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Key study finding</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course content needs to be strongly linked to learners needs. Attendance is enhanced by facilitators with good communication skills who, encourage participation, build challenging exercises into the course content Face-to-face interaction, blended with mixed online achieved better participation /acceptance.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ven with only basic knowledge in the use of ICT, GPs could use new TEL. Majority interested and reacted positivel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o use of e-learning approaches. Outlines some of the efforts undertaken in order to provid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ontemporary medical topics in e-learning form</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onformant and compliant with the internation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tandard SCORM</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e blende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model of delivery encouraged collaboration during both the</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online and face to face class sessions preparing LEND trainees for</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future collaborative practice.</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TimesNewRomanPSMT"/>
                          <a:cs typeface="Times New Roman" panose="02020603050405020304" pitchFamily="18" charset="0"/>
                        </a:rPr>
                        <a:t>Our main finding illustrates the knowledge improvement i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TimesNewRomanPSMT"/>
                          <a:cs typeface="Times New Roman" panose="02020603050405020304" pitchFamily="18" charset="0"/>
                        </a:rPr>
                        <a:t>senology that our e-learning course gave radiographers. Study highlights the importance of e-learning as a training platform, especially in relation to budget constraint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TimesNewRomanPSMT"/>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Success of e learning depends on engaging the learners in an understanding of how the cognitive system works. The e learning platform was developed to deal with technological problems for trainers and also to develop strong conceptual skills for learners to think creatively to problem solve.</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47993" marR="47993"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428397571"/>
                  </a:ext>
                </a:extLst>
              </a:tr>
            </a:tbl>
          </a:graphicData>
        </a:graphic>
      </p:graphicFrame>
    </p:spTree>
    <p:extLst>
      <p:ext uri="{BB962C8B-B14F-4D97-AF65-F5344CB8AC3E}">
        <p14:creationId xmlns:p14="http://schemas.microsoft.com/office/powerpoint/2010/main" val="39464813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E2AABAC3-349E-4535-9C2E-67B497D468B7}"/>
              </a:ext>
            </a:extLst>
          </p:cNvPr>
          <p:cNvGraphicFramePr>
            <a:graphicFrameLocks noGrp="1"/>
          </p:cNvGraphicFramePr>
          <p:nvPr>
            <p:extLst>
              <p:ext uri="{D42A27DB-BD31-4B8C-83A1-F6EECF244321}">
                <p14:modId xmlns:p14="http://schemas.microsoft.com/office/powerpoint/2010/main" val="3646576899"/>
              </p:ext>
            </p:extLst>
          </p:nvPr>
        </p:nvGraphicFramePr>
        <p:xfrm>
          <a:off x="830385" y="474992"/>
          <a:ext cx="10515600" cy="5486400"/>
        </p:xfrm>
        <a:graphic>
          <a:graphicData uri="http://schemas.openxmlformats.org/drawingml/2006/table">
            <a:tbl>
              <a:tblPr firstRow="1" firstCol="1" bandRow="1"/>
              <a:tblGrid>
                <a:gridCol w="1400678">
                  <a:extLst>
                    <a:ext uri="{9D8B030D-6E8A-4147-A177-3AD203B41FA5}">
                      <a16:colId xmlns:a16="http://schemas.microsoft.com/office/drawing/2014/main" val="3832407879"/>
                    </a:ext>
                  </a:extLst>
                </a:gridCol>
                <a:gridCol w="1951695">
                  <a:extLst>
                    <a:ext uri="{9D8B030D-6E8A-4147-A177-3AD203B41FA5}">
                      <a16:colId xmlns:a16="http://schemas.microsoft.com/office/drawing/2014/main" val="2041534875"/>
                    </a:ext>
                  </a:extLst>
                </a:gridCol>
                <a:gridCol w="1983242">
                  <a:extLst>
                    <a:ext uri="{9D8B030D-6E8A-4147-A177-3AD203B41FA5}">
                      <a16:colId xmlns:a16="http://schemas.microsoft.com/office/drawing/2014/main" val="461400384"/>
                    </a:ext>
                  </a:extLst>
                </a:gridCol>
                <a:gridCol w="1522659">
                  <a:extLst>
                    <a:ext uri="{9D8B030D-6E8A-4147-A177-3AD203B41FA5}">
                      <a16:colId xmlns:a16="http://schemas.microsoft.com/office/drawing/2014/main" val="1616530060"/>
                    </a:ext>
                  </a:extLst>
                </a:gridCol>
                <a:gridCol w="1676187">
                  <a:extLst>
                    <a:ext uri="{9D8B030D-6E8A-4147-A177-3AD203B41FA5}">
                      <a16:colId xmlns:a16="http://schemas.microsoft.com/office/drawing/2014/main" val="1064587571"/>
                    </a:ext>
                  </a:extLst>
                </a:gridCol>
                <a:gridCol w="1981139">
                  <a:extLst>
                    <a:ext uri="{9D8B030D-6E8A-4147-A177-3AD203B41FA5}">
                      <a16:colId xmlns:a16="http://schemas.microsoft.com/office/drawing/2014/main" val="4109401904"/>
                    </a:ext>
                  </a:extLst>
                </a:gridCol>
              </a:tblGrid>
              <a:tr h="242761">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afwat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chneiderman. J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ranacharoenpong.K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Walsh, K 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Wang F.</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b="1">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Westbrook.et al</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197810494"/>
                  </a:ext>
                </a:extLst>
              </a:tr>
              <a:tr h="971044">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Learning for healthcare professionals towards HIS Egyp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Demonstrating the</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Effectiveness of an Online,</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Computer-Based Learning</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Module for Arterial Bloo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Gas Analysis</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rocess and Outcome Evaluation of a Diabet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revention Education Program for Communit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ealthcare Workers in Thailan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educational tools developed by Heart to improve th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knowledge and skills of hospital doctors in cardiolog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Valuation of Online Continuing Medical Education and Telemedicine i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aiwa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Collaborative Learning in Healthcare educa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040524715"/>
                  </a:ext>
                </a:extLst>
              </a:tr>
              <a:tr h="242761">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se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RC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se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se stud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ixed metho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332434488"/>
                  </a:ext>
                </a:extLst>
              </a:tr>
              <a:tr h="121381">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ealthcare Profession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urs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ommunity Health worker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ealthcare Profession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hysician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Healthcare professional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075122232"/>
                  </a:ext>
                </a:extLst>
              </a:tr>
              <a:tr h="121381">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o dat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58</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69</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800</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Not clear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19</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066098858"/>
                  </a:ext>
                </a:extLst>
              </a:tr>
              <a:tr h="121381">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WBT and CB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 Learn module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Blended onlin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 learn/multi media</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blende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collaborativ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119484705"/>
                  </a:ext>
                </a:extLst>
              </a:tr>
              <a:tr h="242761">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hemed surve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Pre + post test knowledge scor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AU" sz="1000">
                          <a:effectLst/>
                          <a:latin typeface="Times New Roman" panose="02020603050405020304" pitchFamily="18" charset="0"/>
                          <a:ea typeface="Calibri" panose="020F0502020204030204" pitchFamily="34" charset="0"/>
                          <a:cs typeface="Times New Roman" panose="02020603050405020304" pitchFamily="18" charset="0"/>
                        </a:rPr>
                        <a:t>Pre +post knowledge score + user satisfac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elf survey /pre+ post knowledge tes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Economic and systematic framework</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almon 5 stage model+survey</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850435513"/>
                  </a:ext>
                </a:extLst>
              </a:tr>
              <a:tr h="2063469">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WBT proved to be better for training healthcare staff over CBT as provided more support while learning. CBT needed clearer objectives and increased motivational content for earner engagement. Needs analysis carried out and selected strategies both met the learning objectives and enhanced the learning proces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Demonstrated that an onlin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omputer-based learning module increased staff nurses ’knowledge of ABG interpretation. Improvement was</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irrespective of experience or whether the nurse worked i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he ICU, emergency department, or hospital ward.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The training program was feasible, enjoyable and improved diabetes knowledge. The structure of the training (e.g., interactive versus didactic) was different from participants’ former training experiences, process evaluation indicated their positive responses to the approach, including that it was fun, culturally-relevant.</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Online learning</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modules appear to be effective at helping doctors learn about comm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cardiology problems. Improvements i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knowledge and problem solving skills were demonstrated as a result of the educational intervention.</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Studies on welfare valuation of telecommunication health services with online learning systems are limited. Based on a welfare concept valuation method approach, a positive</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analysis of telemedicine was provided.</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e implementation of three online collaborative initiatives within the programme delivery enhanced student socialisation, enabled students to work together to understan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e learning outcomes and to learn from each other in the development of an assessment. Learners valued these activities and improved</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their experience of distance learning.</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p>
                      <a:pPr>
                        <a:spcAft>
                          <a:spcPts val="0"/>
                        </a:spcAft>
                      </a:pPr>
                      <a:r>
                        <a:rPr lang="en-GB" sz="1000" dirty="0">
                          <a:effectLst/>
                          <a:latin typeface="Times New Roman" panose="02020603050405020304" pitchFamily="18" charset="0"/>
                          <a:ea typeface="Cambria" panose="02040503050406030204" pitchFamily="18" charset="0"/>
                          <a:cs typeface="Times New Roman" panose="02020603050405020304" pitchFamily="18" charset="0"/>
                        </a:rPr>
                        <a:t> </a:t>
                      </a:r>
                      <a:endParaRPr lang="en-GB" sz="1000" dirty="0">
                        <a:effectLst/>
                        <a:latin typeface="Cambria" panose="02040503050406030204" pitchFamily="18" charset="0"/>
                        <a:ea typeface="Times New Roman" panose="02020603050405020304" pitchFamily="18" charset="0"/>
                        <a:cs typeface="Times New Roman" panose="02020603050405020304" pitchFamily="18" charset="0"/>
                      </a:endParaRPr>
                    </a:p>
                  </a:txBody>
                  <a:tcPr marL="60690" marR="6069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464252201"/>
                  </a:ext>
                </a:extLst>
              </a:tr>
            </a:tbl>
          </a:graphicData>
        </a:graphic>
      </p:graphicFrame>
    </p:spTree>
    <p:extLst>
      <p:ext uri="{BB962C8B-B14F-4D97-AF65-F5344CB8AC3E}">
        <p14:creationId xmlns:p14="http://schemas.microsoft.com/office/powerpoint/2010/main" val="40205024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TotalTime>
  <Words>1508</Words>
  <Application>Microsoft Office PowerPoint</Application>
  <PresentationFormat>Widescreen</PresentationFormat>
  <Paragraphs>308</Paragraphs>
  <Slides>4</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vt:i4>
      </vt:variant>
    </vt:vector>
  </HeadingPairs>
  <TitlesOfParts>
    <vt:vector size="11" baseType="lpstr">
      <vt:lpstr>Arial</vt:lpstr>
      <vt:lpstr>Calibri</vt:lpstr>
      <vt:lpstr>Calibri Light</vt:lpstr>
      <vt:lpstr>Cambria</vt:lpstr>
      <vt:lpstr>Times New Roman</vt:lpstr>
      <vt:lpstr>TimesNewRomanPSMT</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m Nicoll</dc:creator>
  <cp:lastModifiedBy>Travis Brooke-Bisschop</cp:lastModifiedBy>
  <cp:revision>4</cp:revision>
  <dcterms:created xsi:type="dcterms:W3CDTF">2018-01-16T16:08:06Z</dcterms:created>
  <dcterms:modified xsi:type="dcterms:W3CDTF">2018-03-17T17:40:32Z</dcterms:modified>
</cp:coreProperties>
</file>